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22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58C4BC-8CB3-5E44-B7B5-58C53EE019C5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81E8A7-D7B0-3643-86BB-D63868C176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73923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A6E562-CA7E-9F4D-8BBD-072145F7BB7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95293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E1080D9-B4DB-53F7-620D-D638B28F0D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48D6CF0-F529-3100-93AE-183A95F8C62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28C844E-BCB6-CFBB-56AF-B9F58CA8D7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A7B65-CD0A-B743-AF63-92A7BD347189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413C9AD-3ABA-1C13-CFC6-8F077B48D5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C57718C-F2E8-6968-BF6D-D6E007879C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FFA3B-DB39-6743-9393-B8A0F0BE42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61247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1248104-4D4B-57F2-3980-077E6EB32C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B35C556-40A5-732E-F59B-F56F7EFA75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CC3E4C1-94DC-D999-ECAB-3F67FFB821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A7B65-CD0A-B743-AF63-92A7BD347189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6D10284-88B4-E410-BD92-19A7A348FC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1C0C59C-4D89-1E07-D73B-08B263A39F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FFA3B-DB39-6743-9393-B8A0F0BE42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86938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4A30C1E-32DE-531D-1FED-03E87BD958A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CB8F945-E3C2-4796-201E-5FDBFBC9D5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A26BAB2-26FC-0F03-6203-9167454E8E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A7B65-CD0A-B743-AF63-92A7BD347189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F730CFF-1660-8AF2-C9A4-4B847D7350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C8DF399-EE63-1C86-9B87-721132B907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FFA3B-DB39-6743-9393-B8A0F0BE42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98396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A681F6B-F3E4-F8CA-1096-6DA3723372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70F2F9F-9F1A-7F47-1816-2BCDE8BF50A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775E326-527A-4A38-68B7-24A80C780D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A7B65-CD0A-B743-AF63-92A7BD347189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87F2EE4-B54B-99AB-1157-53E41E55C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2B711CE-0FFA-E306-080F-F107485429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FFA3B-DB39-6743-9393-B8A0F0BE42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89234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AD615A-806C-F54C-DECA-BDBE33F459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6FC4520-FDDC-8DE5-40E9-9D6D78C855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A6109DD-4E92-C1E5-5F74-2828566F9D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A7B65-CD0A-B743-AF63-92A7BD347189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41D8D68-1F4B-E8D1-8984-F6489CFC35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55B5FE2-90CB-16D0-45F9-E3A7A5D3D4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FFA3B-DB39-6743-9393-B8A0F0BE42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36258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74C683C-3598-D411-550F-E43B62DF10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98331F9-70DA-284F-F0E0-674E55894E1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6C401A1-86C3-8054-C2A8-ACE500B565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F98C36D-11F3-A45F-B3A9-F7E1881CDE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A7B65-CD0A-B743-AF63-92A7BD347189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DCB905A-B077-46FA-12C2-4375A991FC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92A7B21-D9E9-E495-81EF-8B70EE28E9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FFA3B-DB39-6743-9393-B8A0F0BE42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28098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1990B02-A5A7-A33C-4954-440E51786D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9253297-9093-2111-321E-56C0BE65AE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F8582CD-017D-8B85-CC7E-767584BE6C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B569F3A-B966-6C25-2194-B27CBC418B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3B99211-50FB-2D6F-5D1E-9CAEF4AEC66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832A8FB-9DE2-986E-3794-E76F0E42C7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A7B65-CD0A-B743-AF63-92A7BD347189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1E663BA-20DD-31CC-5526-8890E6AAAF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0AEC8B9-9A11-DB4A-4D86-BE8A6F7510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FFA3B-DB39-6743-9393-B8A0F0BE42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7902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8B628DB-810E-09B6-712B-1573D73465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2469A34-33BE-B2F5-BE8E-A62488D391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A7B65-CD0A-B743-AF63-92A7BD347189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937A955-7870-8D73-4022-C10A36CFEA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678CC58-E61F-DDF3-E438-897E312795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FFA3B-DB39-6743-9393-B8A0F0BE42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0813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4C0ECBC-F405-645E-5E75-E163D27CF9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A7B65-CD0A-B743-AF63-92A7BD347189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8C7F3D9-56F6-3594-609F-9DA3E065FC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77D7B9D-CFC3-84B8-28B1-F5ECDA591C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FFA3B-DB39-6743-9393-B8A0F0BE42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7051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D339F00-2856-6EF7-9D24-A53B656081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2684B56-6D3C-1728-50B7-0583A0D38D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9B9A2FE-F59A-41C2-3DFD-FA4B770887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6F0EE22-D764-6866-3B4E-CE54AD03AE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A7B65-CD0A-B743-AF63-92A7BD347189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6110E7D-268B-246D-25C9-E7910790BE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8C5ABC2-9A4D-BB4A-875C-7FA94CC666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FFA3B-DB39-6743-9393-B8A0F0BE42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0157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AAA9DD1-5B9E-0C5D-88BA-EEAEFAEFF3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9D1F80E-8A0D-D798-6180-C1E4B677EE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0E36A79-2EE8-7323-7BDB-865E2D4300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A84D122-C1AB-EDA1-1A4A-809AA22204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A7B65-CD0A-B743-AF63-92A7BD347189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3E167E1-1682-856B-8D1B-3ACCD12CAA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DFD1DD0-8714-C964-FA24-451BBD3AAD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FFA3B-DB39-6743-9393-B8A0F0BE42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1991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B3F653E-85B6-626D-39BE-68F2E92670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D933400-1876-8DBA-EF0B-5FA9260CC9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562E813-0AE6-4A47-8DD0-927D92D19C8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23A7B65-CD0A-B743-AF63-92A7BD347189}" type="datetimeFigureOut">
              <a:rPr kumimoji="1" lang="ja-JP" altLang="en-US" smtClean="0"/>
              <a:t>2026/2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3AF57CC-367A-0C06-23C7-E6985B66CE0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F1B2CD1-B62F-0A3A-2027-602612C3128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55FFA3B-DB39-6743-9393-B8A0F0BE42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1948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4F12F40-C540-8188-D760-EBA80A1FEA6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図 45" descr="グラフ, ヒストグラム&#10;&#10;AI 生成コンテンツは誤りを含む可能性があります。">
            <a:extLst>
              <a:ext uri="{FF2B5EF4-FFF2-40B4-BE49-F238E27FC236}">
                <a16:creationId xmlns:a16="http://schemas.microsoft.com/office/drawing/2014/main" id="{DF48C409-A1B5-F88B-3F9C-980C6465A2F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79300" y="1798277"/>
            <a:ext cx="3600000" cy="3600000"/>
          </a:xfrm>
          <a:prstGeom prst="rect">
            <a:avLst/>
          </a:prstGeom>
        </p:spPr>
      </p:pic>
      <p:pic>
        <p:nvPicPr>
          <p:cNvPr id="44" name="図 43" descr="グラフ&#10;&#10;AI 生成コンテンツは誤りを含む可能性があります。">
            <a:extLst>
              <a:ext uri="{FF2B5EF4-FFF2-40B4-BE49-F238E27FC236}">
                <a16:creationId xmlns:a16="http://schemas.microsoft.com/office/drawing/2014/main" id="{4FA9F637-25DA-5E0D-DCBF-2D6760A5A78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96000" y="1798277"/>
            <a:ext cx="3600000" cy="3600000"/>
          </a:xfrm>
          <a:prstGeom prst="rect">
            <a:avLst/>
          </a:prstGeom>
        </p:spPr>
      </p:pic>
      <p:pic>
        <p:nvPicPr>
          <p:cNvPr id="12" name="図 11" descr="グラフ, 散布図&#10;&#10;AI 生成コンテンツは誤りを含む可能性があります。">
            <a:extLst>
              <a:ext uri="{FF2B5EF4-FFF2-40B4-BE49-F238E27FC236}">
                <a16:creationId xmlns:a16="http://schemas.microsoft.com/office/drawing/2014/main" id="{33FF4AD6-8801-8F21-857E-BA2BA9B0E81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2700" y="1798277"/>
            <a:ext cx="3600000" cy="3600000"/>
          </a:xfrm>
          <a:prstGeom prst="rect">
            <a:avLst/>
          </a:prstGeom>
        </p:spPr>
      </p:pic>
      <p:sp>
        <p:nvSpPr>
          <p:cNvPr id="3" name="タイトル 1">
            <a:extLst>
              <a:ext uri="{FF2B5EF4-FFF2-40B4-BE49-F238E27FC236}">
                <a16:creationId xmlns:a16="http://schemas.microsoft.com/office/drawing/2014/main" id="{A20CDFF4-F801-DFB7-4B03-5C94D32D56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0"/>
            <a:ext cx="10515600" cy="1325563"/>
          </a:xfrm>
        </p:spPr>
        <p:txBody>
          <a:bodyPr>
            <a:normAutofit/>
          </a:bodyPr>
          <a:lstStyle/>
          <a:p>
            <a:r>
              <a:rPr kumimoji="1" lang="en-US" altLang="ja-JP" sz="2400" dirty="0">
                <a:latin typeface="Calibri" panose="020F0502020204030204" pitchFamily="34" charset="0"/>
                <a:cs typeface="Calibri" panose="020F0502020204030204" pitchFamily="34" charset="0"/>
              </a:rPr>
              <a:t>Figure S3.</a:t>
            </a:r>
            <a:endParaRPr kumimoji="1" lang="ja-JP" altLang="en-US" sz="2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5374AE04-0F9D-1CF9-0D6E-6331336BD443}"/>
              </a:ext>
            </a:extLst>
          </p:cNvPr>
          <p:cNvSpPr txBox="1"/>
          <p:nvPr/>
        </p:nvSpPr>
        <p:spPr>
          <a:xfrm rot="16200000">
            <a:off x="105655" y="3367443"/>
            <a:ext cx="1136530" cy="123111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Overall survival (months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0" name="表 2">
            <a:extLst>
              <a:ext uri="{FF2B5EF4-FFF2-40B4-BE49-F238E27FC236}">
                <a16:creationId xmlns:a16="http://schemas.microsoft.com/office/drawing/2014/main" id="{04BFC2C3-E35C-9373-2FE8-2DF134EE284C}"/>
              </a:ext>
            </a:extLst>
          </p:cNvPr>
          <p:cNvGraphicFramePr>
            <a:graphicFrameLocks noGrp="1"/>
          </p:cNvGraphicFramePr>
          <p:nvPr/>
        </p:nvGraphicFramePr>
        <p:xfrm>
          <a:off x="9688318" y="2108021"/>
          <a:ext cx="2090982" cy="968399"/>
        </p:xfrm>
        <a:graphic>
          <a:graphicData uri="http://schemas.openxmlformats.org/drawingml/2006/table">
            <a:tbl>
              <a:tblPr firstRow="1" bandRow="1"/>
              <a:tblGrid>
                <a:gridCol w="870513">
                  <a:extLst>
                    <a:ext uri="{9D8B030D-6E8A-4147-A177-3AD203B41FA5}">
                      <a16:colId xmlns:a16="http://schemas.microsoft.com/office/drawing/2014/main" val="2301636050"/>
                    </a:ext>
                  </a:extLst>
                </a:gridCol>
                <a:gridCol w="397827">
                  <a:extLst>
                    <a:ext uri="{9D8B030D-6E8A-4147-A177-3AD203B41FA5}">
                      <a16:colId xmlns:a16="http://schemas.microsoft.com/office/drawing/2014/main" val="4166505210"/>
                    </a:ext>
                  </a:extLst>
                </a:gridCol>
                <a:gridCol w="822642">
                  <a:extLst>
                    <a:ext uri="{9D8B030D-6E8A-4147-A177-3AD203B41FA5}">
                      <a16:colId xmlns:a16="http://schemas.microsoft.com/office/drawing/2014/main" val="532266747"/>
                    </a:ext>
                  </a:extLst>
                </a:gridCol>
              </a:tblGrid>
              <a:tr h="335779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vent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, </a:t>
                      </a:r>
                      <a:r>
                        <a:rPr kumimoji="1" lang="en-US" altLang="ja-JP" sz="8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35733391"/>
                  </a:ext>
                </a:extLst>
              </a:tr>
              <a:tr h="316310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E0526B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I-long (n=12)</a:t>
                      </a:r>
                      <a:endParaRPr kumimoji="1" lang="ja-JP" altLang="en-US" sz="800" b="1" dirty="0">
                        <a:solidFill>
                          <a:srgbClr val="E0526B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E0526B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kumimoji="1" lang="ja-JP" altLang="en-US" sz="800" b="1" dirty="0">
                        <a:solidFill>
                          <a:srgbClr val="E0526B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E0526B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9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E0526B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.3-35.4)</a:t>
                      </a:r>
                    </a:p>
                  </a:txBody>
                  <a:tcPr marL="36000" marR="36000" marT="36000" marB="360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5528354"/>
                  </a:ext>
                </a:extLst>
              </a:tr>
              <a:tr h="316310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I-short (n=8)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4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4-12.2)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3600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289549"/>
                  </a:ext>
                </a:extLst>
              </a:tr>
            </a:tbl>
          </a:graphicData>
        </a:graphic>
      </p:graphicFrame>
      <p:graphicFrame>
        <p:nvGraphicFramePr>
          <p:cNvPr id="31" name="表 2">
            <a:extLst>
              <a:ext uri="{FF2B5EF4-FFF2-40B4-BE49-F238E27FC236}">
                <a16:creationId xmlns:a16="http://schemas.microsoft.com/office/drawing/2014/main" id="{6D51A140-8A1B-4D5D-1A10-BE32672D95EB}"/>
              </a:ext>
            </a:extLst>
          </p:cNvPr>
          <p:cNvGraphicFramePr>
            <a:graphicFrameLocks noGrp="1"/>
          </p:cNvGraphicFramePr>
          <p:nvPr/>
        </p:nvGraphicFramePr>
        <p:xfrm>
          <a:off x="5785578" y="2108021"/>
          <a:ext cx="2110422" cy="1006339"/>
        </p:xfrm>
        <a:graphic>
          <a:graphicData uri="http://schemas.openxmlformats.org/drawingml/2006/table">
            <a:tbl>
              <a:tblPr firstRow="1" bandRow="1"/>
              <a:tblGrid>
                <a:gridCol w="889953">
                  <a:extLst>
                    <a:ext uri="{9D8B030D-6E8A-4147-A177-3AD203B41FA5}">
                      <a16:colId xmlns:a16="http://schemas.microsoft.com/office/drawing/2014/main" val="2301636050"/>
                    </a:ext>
                  </a:extLst>
                </a:gridCol>
                <a:gridCol w="397827">
                  <a:extLst>
                    <a:ext uri="{9D8B030D-6E8A-4147-A177-3AD203B41FA5}">
                      <a16:colId xmlns:a16="http://schemas.microsoft.com/office/drawing/2014/main" val="4166505210"/>
                    </a:ext>
                  </a:extLst>
                </a:gridCol>
                <a:gridCol w="822642">
                  <a:extLst>
                    <a:ext uri="{9D8B030D-6E8A-4147-A177-3AD203B41FA5}">
                      <a16:colId xmlns:a16="http://schemas.microsoft.com/office/drawing/2014/main" val="532266747"/>
                    </a:ext>
                  </a:extLst>
                </a:gridCol>
              </a:tblGrid>
              <a:tr h="335779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vent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b="1" kern="1200">
                          <a:solidFill>
                            <a:schemeClr val="lt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, </a:t>
                      </a:r>
                      <a:r>
                        <a:rPr kumimoji="1" lang="en-US" altLang="ja-JP" sz="8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35733391"/>
                  </a:ext>
                </a:extLst>
              </a:tr>
              <a:tr h="316310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E0526B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I-long (n=12)</a:t>
                      </a:r>
                      <a:endParaRPr kumimoji="1" lang="ja-JP" altLang="en-US" sz="800" b="1" dirty="0">
                        <a:solidFill>
                          <a:srgbClr val="E0526B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E0526B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kumimoji="1" lang="ja-JP" altLang="en-US" sz="800" b="1" dirty="0">
                        <a:solidFill>
                          <a:srgbClr val="E0526B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E0526B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6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rgbClr val="E0526B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4.7-23.3)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5528354"/>
                  </a:ext>
                </a:extLst>
              </a:tr>
              <a:tr h="316310"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I-short (n=10)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1pPr>
                      <a:lvl2pPr marL="3429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2pPr>
                      <a:lvl3pPr marL="6858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3pPr>
                      <a:lvl4pPr marL="10287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4pPr>
                      <a:lvl5pPr marL="13716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5pPr>
                      <a:lvl6pPr marL="17145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6pPr>
                      <a:lvl7pPr marL="20574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7pPr>
                      <a:lvl8pPr marL="24003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8pPr>
                      <a:lvl9pPr marL="2743200" algn="l" defTabSz="685800" rtl="0" eaLnBrk="1" latinLnBrk="0" hangingPunct="1">
                        <a:defRPr kumimoji="1" sz="1350" kern="1200">
                          <a:solidFill>
                            <a:schemeClr val="dk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</a:t>
                      </a:r>
                    </a:p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4-7.1)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289549"/>
                  </a:ext>
                </a:extLst>
              </a:tr>
            </a:tbl>
          </a:graphicData>
        </a:graphic>
      </p:graphicFrame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6D17CDE7-993B-7FD7-62CC-444A4E7AC976}"/>
              </a:ext>
            </a:extLst>
          </p:cNvPr>
          <p:cNvSpPr txBox="1"/>
          <p:nvPr/>
        </p:nvSpPr>
        <p:spPr>
          <a:xfrm>
            <a:off x="412700" y="1798277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D80A2DDC-7AB8-C6E0-BB01-8DC3CE625550}"/>
              </a:ext>
            </a:extLst>
          </p:cNvPr>
          <p:cNvSpPr txBox="1"/>
          <p:nvPr/>
        </p:nvSpPr>
        <p:spPr>
          <a:xfrm>
            <a:off x="4296000" y="179827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3444D2DC-6B60-C4F3-E744-60350DC369E1}"/>
              </a:ext>
            </a:extLst>
          </p:cNvPr>
          <p:cNvCxnSpPr/>
          <p:nvPr/>
        </p:nvCxnSpPr>
        <p:spPr>
          <a:xfrm>
            <a:off x="5668700" y="2947529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3DD6F421-0A4F-1191-28CF-2DAF6BB5F603}"/>
              </a:ext>
            </a:extLst>
          </p:cNvPr>
          <p:cNvCxnSpPr>
            <a:cxnSpLocks/>
          </p:cNvCxnSpPr>
          <p:nvPr/>
        </p:nvCxnSpPr>
        <p:spPr>
          <a:xfrm>
            <a:off x="5668700" y="2598754"/>
            <a:ext cx="144000" cy="0"/>
          </a:xfrm>
          <a:prstGeom prst="line">
            <a:avLst/>
          </a:prstGeom>
          <a:ln w="19050">
            <a:solidFill>
              <a:srgbClr val="E0526B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7587CE54-1648-A6E3-0680-AE5C2119B1BF}"/>
              </a:ext>
            </a:extLst>
          </p:cNvPr>
          <p:cNvSpPr txBox="1"/>
          <p:nvPr/>
        </p:nvSpPr>
        <p:spPr>
          <a:xfrm>
            <a:off x="6919451" y="3095420"/>
            <a:ext cx="9765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Log-rank p=0.05</a:t>
            </a:r>
          </a:p>
        </p:txBody>
      </p: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D06FF743-66ED-095C-F74E-F2F085675BEF}"/>
              </a:ext>
            </a:extLst>
          </p:cNvPr>
          <p:cNvCxnSpPr/>
          <p:nvPr/>
        </p:nvCxnSpPr>
        <p:spPr>
          <a:xfrm>
            <a:off x="9550105" y="2912360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0584F2A1-9EF6-68EF-4AE8-ADD0B070BF74}"/>
              </a:ext>
            </a:extLst>
          </p:cNvPr>
          <p:cNvCxnSpPr>
            <a:cxnSpLocks/>
          </p:cNvCxnSpPr>
          <p:nvPr/>
        </p:nvCxnSpPr>
        <p:spPr>
          <a:xfrm>
            <a:off x="9544318" y="2599467"/>
            <a:ext cx="144000" cy="0"/>
          </a:xfrm>
          <a:prstGeom prst="line">
            <a:avLst/>
          </a:prstGeom>
          <a:ln w="19050">
            <a:solidFill>
              <a:srgbClr val="E0526B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CFB6A0FD-231E-63FF-84D7-33DE3248F61A}"/>
              </a:ext>
            </a:extLst>
          </p:cNvPr>
          <p:cNvSpPr txBox="1"/>
          <p:nvPr/>
        </p:nvSpPr>
        <p:spPr>
          <a:xfrm>
            <a:off x="10802751" y="3095420"/>
            <a:ext cx="9765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Log-rank p=0.06</a:t>
            </a: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7EBC2858-768E-EEF1-7BF7-B0FB35F5B042}"/>
              </a:ext>
            </a:extLst>
          </p:cNvPr>
          <p:cNvSpPr txBox="1"/>
          <p:nvPr/>
        </p:nvSpPr>
        <p:spPr>
          <a:xfrm>
            <a:off x="8179300" y="1798277"/>
            <a:ext cx="282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kumimoji="1" lang="ja-JP" altLang="en-US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37DFAB75-A013-08C9-89E1-8E0D214D381D}"/>
              </a:ext>
            </a:extLst>
          </p:cNvPr>
          <p:cNvSpPr txBox="1"/>
          <p:nvPr/>
        </p:nvSpPr>
        <p:spPr>
          <a:xfrm>
            <a:off x="1549400" y="4974110"/>
            <a:ext cx="1792478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rastuzumab-free interval (months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EECBEDAD-C1EB-6856-567D-8B3588AF8C0F}"/>
              </a:ext>
            </a:extLst>
          </p:cNvPr>
          <p:cNvSpPr txBox="1"/>
          <p:nvPr/>
        </p:nvSpPr>
        <p:spPr>
          <a:xfrm>
            <a:off x="2627488" y="2152850"/>
            <a:ext cx="11849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rho=0.41, p=0.07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3BDA3267-D93B-2B53-0C48-1C262CC4A6E7}"/>
              </a:ext>
            </a:extLst>
          </p:cNvPr>
          <p:cNvSpPr txBox="1"/>
          <p:nvPr/>
        </p:nvSpPr>
        <p:spPr>
          <a:xfrm rot="16200000">
            <a:off x="3766268" y="3322922"/>
            <a:ext cx="1510350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rogression-free survival (%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67BFA1C0-7380-2259-362D-F92FA407DFDE}"/>
              </a:ext>
            </a:extLst>
          </p:cNvPr>
          <p:cNvSpPr txBox="1"/>
          <p:nvPr/>
        </p:nvSpPr>
        <p:spPr>
          <a:xfrm rot="16200000">
            <a:off x="7882062" y="3324982"/>
            <a:ext cx="1074333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Overall survival (%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5A752B6E-6686-7D68-6DC8-95BA209F54B5}"/>
              </a:ext>
            </a:extLst>
          </p:cNvPr>
          <p:cNvSpPr txBox="1"/>
          <p:nvPr/>
        </p:nvSpPr>
        <p:spPr>
          <a:xfrm>
            <a:off x="5968261" y="4908781"/>
            <a:ext cx="522900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A256605B-87FC-203E-CE65-2DB7073E6D99}"/>
              </a:ext>
            </a:extLst>
          </p:cNvPr>
          <p:cNvSpPr txBox="1"/>
          <p:nvPr/>
        </p:nvSpPr>
        <p:spPr>
          <a:xfrm>
            <a:off x="9835281" y="4908781"/>
            <a:ext cx="522900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96581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0</Words>
  <Application>Microsoft Macintosh PowerPoint</Application>
  <PresentationFormat>ワイド画面</PresentationFormat>
  <Paragraphs>3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Figure S3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吉野光一郎</dc:creator>
  <cp:lastModifiedBy>Koichiro Yoshino</cp:lastModifiedBy>
  <cp:revision>2</cp:revision>
  <dcterms:created xsi:type="dcterms:W3CDTF">2025-11-04T04:59:12Z</dcterms:created>
  <dcterms:modified xsi:type="dcterms:W3CDTF">2026-02-24T02:34:21Z</dcterms:modified>
</cp:coreProperties>
</file>